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0DECE-4D13-416E-950A-312FB12691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53718-F2D7-4C78-8A7C-3233896367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97D4A-143D-4B87-BDBD-6B144C8706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6C59D-CD10-4A2F-BFD7-F63088A2AB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1D32E-0764-45D3-A982-676B9ED5FC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4D97FE-E487-411F-93A4-ADCCCD3A1F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7A2E1-C6E2-453E-B31F-4DECECC0EC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629A8-09AD-42B5-86FC-B4A027FBC5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22641-CB79-4993-95D2-A97675939D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884A4-0604-4C89-AF5A-D03114FA1F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B46E9-9550-4721-9B20-4F0120AF8A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A024D-C553-47D3-A4CB-3308E71954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B83860-07CF-45EE-9824-F13EF08713B8}" type="datetime">
              <a:rPr b="0" lang="pt-B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07F0E4-EFA7-40A6-8996-69C5F9931643}" type="slidenum">
              <a:rPr b="0" lang="pt-B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0"/>
          <a:ext cx="9144000" cy="6230880"/>
        </p:xfrm>
        <a:graphic>
          <a:graphicData uri="http://schemas.openxmlformats.org/drawingml/2006/table">
            <a:tbl>
              <a:tblPr/>
              <a:tblGrid>
                <a:gridCol w="1627200"/>
                <a:gridCol w="2016000"/>
                <a:gridCol w="2538360"/>
                <a:gridCol w="1773360"/>
                <a:gridCol w="595440"/>
                <a:gridCol w="593640"/>
              </a:tblGrid>
              <a:tr h="279360"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lection Bias - Sequence Generation; Allocation concealme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rformance Bias - Blinding single, two, triple; Other trea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tection bias - blinding, other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lind assessment?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/ Multi          centr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TMS studi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5"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itzgerald, 2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sealed envelop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ulet, 2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56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ppner, 20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lotter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clea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itzgerald, 20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sealed envelop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 Reardon, 2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derson, 2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sealed envelop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o, 2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random number li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lete-case analy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gg, 20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computer li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outros, 2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unclea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56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rcia-Toro, 2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sealed envelop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simann, 2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ltzheimer, 2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regress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Januel, 2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umber li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Jorge, 2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clea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Jorge, 20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clea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, 2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lete-case analy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umi, 2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voice devi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ern, 2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lete-case analy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y, 2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computer li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y, 2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ortolomasi, 2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rwig, 20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clea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rwig, 2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computer li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ausmann, 2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lete-case analy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o, 20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lete-case analy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oerselman, 2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lete-case analy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ssini, 2005 (Psych Re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computer li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lete-case analy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ssini, 2005 (J Clin Psych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computer li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retlau, 20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ngle-blinded with external evalu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citalopram studi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5"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paport, 2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rke, 2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exopoulos, 2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pola, 20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ose, 20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ina, 20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ade, 2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asper, 2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ayton, 2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ierenberg, 2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not repor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agner, 2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domized; computer li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uble-blind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T, LOC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680" marR="46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CaixaDeTexto 5"/>
          <p:cNvSpPr/>
          <p:nvPr/>
        </p:nvSpPr>
        <p:spPr>
          <a:xfrm>
            <a:off x="285840" y="6429240"/>
            <a:ext cx="835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Calibri"/>
              </a:rPr>
              <a:t>Table S1 shows quality assessment of each study included in our meta-analysi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7T18:55:30Z</dcterms:created>
  <dc:creator>ANDRE RUSSOWSKY BRUNONI</dc:creator>
  <dc:description/>
  <dc:language>en-US</dc:language>
  <cp:lastModifiedBy>Andre Brunoni</cp:lastModifiedBy>
  <dcterms:modified xsi:type="dcterms:W3CDTF">2009-02-10T04:24:38Z</dcterms:modified>
  <cp:revision>5</cp:revision>
  <dc:subject/>
  <dc:title>Slide 1</dc:title>
</cp:coreProperties>
</file>